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3" autoAdjust="0"/>
    <p:restoredTop sz="94660"/>
  </p:normalViewPr>
  <p:slideViewPr>
    <p:cSldViewPr snapToGrid="0">
      <p:cViewPr varScale="1">
        <p:scale>
          <a:sx n="90" d="100"/>
          <a:sy n="90" d="100"/>
        </p:scale>
        <p:origin x="102" y="1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9151B9-8862-401B-848F-81A95B7E84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E69F520-A4E0-47E9-90D8-675C00AB8D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7341C5-514A-4F3B-90EB-6D627E9545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25/08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3773BE-0E79-4714-8BD3-063EA1246D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C22A50-9650-4196-84C7-EC426F0028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403186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6E917A-8A17-4C58-98E0-42C366521C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0A907A-51BC-42A6-9B35-8758E363CF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5CF2B5-AC72-4C40-9E55-ECAA141951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25/08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57B827-99DD-4482-9EEC-A7FF2ADA04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1174AF-B4C5-4D27-86FB-A9D0EBDDF4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90646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8327022-9EF1-47A6-9475-B261D7E232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5CC263-B253-4D44-B2E9-C1757B2F1D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B97CAF-1FA8-471B-B473-BAE22CEF0D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25/08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968E6C-DBD9-4007-8AB1-98ED84FF22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29EE9B-1022-4CCC-8A2A-54FD217D6A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93261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179819-40CF-4EF9-924D-28E97E0FB6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9C83DC-615C-4ADB-A607-3967148C25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82AC8E-C181-4E2F-B943-90D5B9270A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25/08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6C5E17-DAC4-4094-ADFA-93AC2DCCD8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B7FF4F-6A31-423D-9FA8-75F156B9F3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83810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3E9571-3F18-40E7-B60A-EB8EEC07A9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A1989B-8B72-4A60-ACFF-93268D84EF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DEF5B8-EE87-4F1F-A7EE-6484D9F4AC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25/08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82E935-EE4D-4AAA-B1F1-6DBF763C86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6A8994-B2AD-48BB-BEA6-5F3028F394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314182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FF9C60-C148-40A8-9D0A-2D5E3BA26A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D5ED34-1B5D-4D27-8089-AC574B97BA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0E5FDC-6FA4-4012-B9B9-344D56AC9C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B3E2A8-73A2-445B-9B05-4702556E9F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25/08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BDB9FA-2152-4336-BC92-D445B01BCD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E2B54E-7721-407F-B0A6-692E295A83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081822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7CA762-2432-459E-BAF0-A5E280E438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7A2F90-CAB4-40FD-BA03-12AD639027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77E9DC-1837-4FC9-852E-45844433CA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318AB67-030D-4395-B638-6F93D85EF7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B841E1-2023-4CC3-BFC3-AB67A997FF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10A20EF-E91F-42AC-964A-E4BD4DA2F5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25/08/2021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DFA7044-5523-4B04-B79F-ED50D93E99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3BB34E0-D818-4004-987B-D19940ACB6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5932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4E9D11-D16C-49F9-8E2F-61F8F31BD0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8D7148E-ACC7-42D2-8D46-4E1DDE5E34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25/08/2021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AE9E805-C592-441C-B31B-BEDE323564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577F3CE-7A61-4C86-9FCC-DE28391B2C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36756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EB37C06-CC77-4631-A1C2-778DFFACD0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25/08/2021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0E63AC3-8976-4D46-A3A8-DDE59419C2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A6C7E69-B959-4EF6-AE45-940164BB7C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029773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3C907B-0EC0-4078-A748-0A44E43B01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7ACB6E-FBD9-4D7F-991C-CE33B97E67C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8A5297-3EF6-4E35-82BA-7CFFED11DD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B1FAD2-C6DF-4A10-B002-DE038B0A8B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25/08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DFCD79-5A0B-4EA4-87EC-37E1B06C8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F9EF8F-DF9C-4336-A009-1AF0CB5DE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29523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037593-7BF5-44F8-8351-DC487129CD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303FE01-69AE-430E-9A94-A893B40CBA6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6B5E9C-5D6C-4FF8-81DD-490C57F1F3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E26561-5B53-4259-900A-751EF7830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21916-CD71-42E6-B9F4-722C62E49577}" type="datetimeFigureOut">
              <a:rPr lang="en-AU" smtClean="0"/>
              <a:t>25/08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F6E35F-652C-474C-9530-B21A862ADA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22E843-ECB4-4654-ACF3-15DBEF833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520126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75AF5AB-2D23-476A-9760-8F5500BD44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AC69AC-EEA0-479B-AA96-044ACAE87A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255C6D-4C72-4CAE-94D8-7291B96DD6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21916-CD71-42E6-B9F4-722C62E49577}" type="datetimeFigureOut">
              <a:rPr lang="en-AU" smtClean="0"/>
              <a:t>25/08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425E77-72D8-485E-8D14-722E79174F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F526E8-B810-4E46-BD37-68901CC401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3BABB4-5D30-4627-A678-1AA2EF3FCF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2135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04008CB-6CB9-494A-8CCB-C58E2415E32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3704" t="36667" r="48333" b="32518"/>
          <a:stretch/>
        </p:blipFill>
        <p:spPr>
          <a:xfrm>
            <a:off x="3753894" y="1429244"/>
            <a:ext cx="2012107" cy="215732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C4CB10B-FE1A-4D8D-82F1-DDA8318C876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3519" t="39926" r="50000" b="29259"/>
          <a:stretch/>
        </p:blipFill>
        <p:spPr>
          <a:xfrm>
            <a:off x="6619856" y="1429244"/>
            <a:ext cx="1846103" cy="215732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FA4E05C-3E36-468A-AE23-2522C8466DAA}"/>
              </a:ext>
            </a:extLst>
          </p:cNvPr>
          <p:cNvSpPr txBox="1"/>
          <p:nvPr/>
        </p:nvSpPr>
        <p:spPr>
          <a:xfrm>
            <a:off x="3311373" y="167394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A6B7756-AB57-4917-82C6-BE643C2C25C2}"/>
              </a:ext>
            </a:extLst>
          </p:cNvPr>
          <p:cNvSpPr txBox="1"/>
          <p:nvPr/>
        </p:nvSpPr>
        <p:spPr>
          <a:xfrm>
            <a:off x="3311373" y="1885856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F7A88B1-9634-4822-BE49-1E7947E1DC17}"/>
              </a:ext>
            </a:extLst>
          </p:cNvPr>
          <p:cNvSpPr txBox="1"/>
          <p:nvPr/>
        </p:nvSpPr>
        <p:spPr>
          <a:xfrm>
            <a:off x="3372627" y="209025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C1B9092-C899-4A7B-B435-022ED8195829}"/>
              </a:ext>
            </a:extLst>
          </p:cNvPr>
          <p:cNvSpPr txBox="1"/>
          <p:nvPr/>
        </p:nvSpPr>
        <p:spPr>
          <a:xfrm>
            <a:off x="3350647" y="238879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68677F1-4C30-403F-A238-AFC083AE11D0}"/>
              </a:ext>
            </a:extLst>
          </p:cNvPr>
          <p:cNvSpPr txBox="1"/>
          <p:nvPr/>
        </p:nvSpPr>
        <p:spPr>
          <a:xfrm>
            <a:off x="3350647" y="261868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F32C932-08E4-4953-A79B-46FC26A066DD}"/>
              </a:ext>
            </a:extLst>
          </p:cNvPr>
          <p:cNvSpPr txBox="1"/>
          <p:nvPr/>
        </p:nvSpPr>
        <p:spPr>
          <a:xfrm rot="16200000">
            <a:off x="3987517" y="968881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VE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5CE959F-DC8A-4CE8-8E20-50DD7A7587A3}"/>
              </a:ext>
            </a:extLst>
          </p:cNvPr>
          <p:cNvSpPr txBox="1"/>
          <p:nvPr/>
        </p:nvSpPr>
        <p:spPr>
          <a:xfrm rot="16200000">
            <a:off x="4350556" y="874277"/>
            <a:ext cx="9140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OS HEK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4944E83-A7C7-4153-BF88-3AF3FE92068F}"/>
              </a:ext>
            </a:extLst>
          </p:cNvPr>
          <p:cNvSpPr txBox="1"/>
          <p:nvPr/>
        </p:nvSpPr>
        <p:spPr>
          <a:xfrm rot="16200000">
            <a:off x="5059419" y="1070068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K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23DF0A1-CEC7-4377-9543-40CC8FFCDB5C}"/>
              </a:ext>
            </a:extLst>
          </p:cNvPr>
          <p:cNvSpPr txBox="1"/>
          <p:nvPr/>
        </p:nvSpPr>
        <p:spPr>
          <a:xfrm rot="16200000">
            <a:off x="6812210" y="978406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VE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9967EEF-1068-42BE-A6B2-61C75FC7D928}"/>
              </a:ext>
            </a:extLst>
          </p:cNvPr>
          <p:cNvSpPr txBox="1"/>
          <p:nvPr/>
        </p:nvSpPr>
        <p:spPr>
          <a:xfrm rot="16200000">
            <a:off x="7175249" y="883802"/>
            <a:ext cx="9140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OS HEK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9E581A7-1D2F-4A7E-9C14-B6126AC906F2}"/>
              </a:ext>
            </a:extLst>
          </p:cNvPr>
          <p:cNvSpPr txBox="1"/>
          <p:nvPr/>
        </p:nvSpPr>
        <p:spPr>
          <a:xfrm rot="16200000">
            <a:off x="7884112" y="1079593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K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8D0E9828-B29A-4930-8C38-3267F09C1F1B}"/>
              </a:ext>
            </a:extLst>
          </p:cNvPr>
          <p:cNvSpPr/>
          <p:nvPr/>
        </p:nvSpPr>
        <p:spPr>
          <a:xfrm>
            <a:off x="3987316" y="1707812"/>
            <a:ext cx="1692165" cy="27699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8E23C6BA-F935-46BC-9614-4DE4F7ED243A}"/>
              </a:ext>
            </a:extLst>
          </p:cNvPr>
          <p:cNvSpPr/>
          <p:nvPr/>
        </p:nvSpPr>
        <p:spPr>
          <a:xfrm>
            <a:off x="6924683" y="1865583"/>
            <a:ext cx="1429099" cy="27699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FE20475-8589-4833-B860-760A8CBA65FC}"/>
              </a:ext>
            </a:extLst>
          </p:cNvPr>
          <p:cNvSpPr txBox="1"/>
          <p:nvPr/>
        </p:nvSpPr>
        <p:spPr>
          <a:xfrm>
            <a:off x="3294438" y="1194168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F2C529E-11BA-459F-8FAB-B5BC38261B94}"/>
              </a:ext>
            </a:extLst>
          </p:cNvPr>
          <p:cNvSpPr txBox="1"/>
          <p:nvPr/>
        </p:nvSpPr>
        <p:spPr>
          <a:xfrm>
            <a:off x="2732931" y="950763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A4A34F6-D71C-469F-A761-325BD2F34BD1}"/>
              </a:ext>
            </a:extLst>
          </p:cNvPr>
          <p:cNvSpPr txBox="1"/>
          <p:nvPr/>
        </p:nvSpPr>
        <p:spPr>
          <a:xfrm>
            <a:off x="6184498" y="967863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E36AE06-7C48-42C4-921E-49A4AC290B0F}"/>
              </a:ext>
            </a:extLst>
          </p:cNvPr>
          <p:cNvSpPr txBox="1"/>
          <p:nvPr/>
        </p:nvSpPr>
        <p:spPr>
          <a:xfrm>
            <a:off x="1715554" y="4022903"/>
            <a:ext cx="8937887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b="1" dirty="0"/>
              <a:t>Supplemental Figure 1. </a:t>
            </a:r>
            <a:r>
              <a:rPr lang="en-AU" dirty="0"/>
              <a:t>Confirmation of the specificity of the eNOS and eNOS-P antibodies. </a:t>
            </a:r>
            <a:r>
              <a:rPr lang="en-AU" b="1" dirty="0"/>
              <a:t>A.</a:t>
            </a:r>
            <a:r>
              <a:rPr lang="en-AU" dirty="0"/>
              <a:t> Immunoblot (10 sec exposure) showing the specificity of the mouse anti-eNOS monoclonal primary antibody. A 140 kDa band was observed in HUVEC and eNOS-transfected human embryonic kidney (HEK) cells but not in HEK cells. </a:t>
            </a:r>
            <a:r>
              <a:rPr lang="en-AU" b="1" dirty="0"/>
              <a:t>B.</a:t>
            </a:r>
            <a:r>
              <a:rPr lang="en-AU" dirty="0"/>
              <a:t> Immunoblot (2 min exposure) showing the specificity of the rabbit anti-eNOS-P polyclonal primary antibody. A strong band was observed in eNOS-transfected HEK cells, a faint band was observed in HUVEC and no band was observed in HEK cells.</a:t>
            </a:r>
          </a:p>
        </p:txBody>
      </p:sp>
    </p:spTree>
    <p:extLst>
      <p:ext uri="{BB962C8B-B14F-4D97-AF65-F5344CB8AC3E}">
        <p14:creationId xmlns:p14="http://schemas.microsoft.com/office/powerpoint/2010/main" val="27695442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120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ke Sokoya</dc:creator>
  <cp:lastModifiedBy>Elke Sokoya</cp:lastModifiedBy>
  <cp:revision>19</cp:revision>
  <dcterms:created xsi:type="dcterms:W3CDTF">2021-07-12T05:07:12Z</dcterms:created>
  <dcterms:modified xsi:type="dcterms:W3CDTF">2021-08-25T00:09:24Z</dcterms:modified>
</cp:coreProperties>
</file>